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83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7956A0-AAC4-41D9-AB53-20C2C3120A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8C650-AD19-40BF-A10B-EA4888ECDD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8D26D-B6A5-44C7-AB04-0757372536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681F1-F3B1-4ECF-BDAC-D066DA3AA7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D0B02-1EA3-4271-BF64-93C2A3031C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D78B3-8C2F-4300-A942-EA677FE883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9DF050-4915-48C1-AA61-E3C7B1956A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E7933-00FB-4F21-A5E0-AA61345E53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A7C44-B4F1-4795-BE12-DAE68C266F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4E3416-F7FF-4A4C-8DAF-0358568CD3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65AC49-B2D3-4DD8-8DAA-26BE0888F6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C39233-2F25-4B54-B21D-EA23C92880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C74056-FA39-4619-9897-E34D0531D9A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14400" y="2438280"/>
          <a:ext cx="4971960" cy="2706840"/>
        </p:xfrm>
        <a:graphic>
          <a:graphicData uri="http://schemas.openxmlformats.org/drawingml/2006/table">
            <a:tbl>
              <a:tblPr/>
              <a:tblGrid>
                <a:gridCol w="1876320"/>
                <a:gridCol w="851040"/>
                <a:gridCol w="961920"/>
                <a:gridCol w="1282680"/>
              </a:tblGrid>
              <a:tr h="595440">
                <a:tc rowSpan="2"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lasma sour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Viral RNA (copies/ml) before and after ultracentrifug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old increa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efor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ft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58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Ri-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Undetect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58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Tr-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Undetect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Ge-1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,7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6,1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.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460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8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Fa-10 (positive control)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29,65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984,3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7.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88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lasma from naïve R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&lt;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Undetecte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066680" y="5562720"/>
            <a:ext cx="1657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able S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03T20:44:20Z</dcterms:created>
  <dc:creator>Partners Information Systems</dc:creator>
  <dc:description/>
  <dc:language>en-US</dc:language>
  <cp:lastModifiedBy>Partners Information Systems</cp:lastModifiedBy>
  <dcterms:modified xsi:type="dcterms:W3CDTF">2011-03-29T16:01:20Z</dcterms:modified>
  <cp:revision>16</cp:revision>
  <dc:subject/>
  <dc:title>Slide 1</dc:title>
</cp:coreProperties>
</file>